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  <p:sldId id="256" r:id="rId3"/>
    <p:sldId id="257" r:id="rId4"/>
    <p:sldId id="258" r:id="rId5"/>
    <p:sldId id="259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ditor" initials="Ed" lastIdx="1" clrIdx="0">
    <p:extLst>
      <p:ext uri="{19B8F6BF-5375-455C-9EA6-DF929625EA0E}">
        <p15:presenceInfo xmlns:p15="http://schemas.microsoft.com/office/powerpoint/2012/main" userId="Edit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859"/>
    <p:restoredTop sz="96405"/>
  </p:normalViewPr>
  <p:slideViewPr>
    <p:cSldViewPr snapToGrid="0" snapToObjects="1" showGuides="1">
      <p:cViewPr varScale="1">
        <p:scale>
          <a:sx n="109" d="100"/>
          <a:sy n="109" d="100"/>
        </p:scale>
        <p:origin x="114" y="17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dirty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ABEE-D57A-7D44-8961-422A86E6230B}" type="datetimeFigureOut">
              <a:t>2022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642E-D1AF-5648-8619-8490CD5329B2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8830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ABEE-D57A-7D44-8961-422A86E6230B}" type="datetimeFigureOut">
              <a:t>2022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642E-D1AF-5648-8619-8490CD5329B2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693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ABEE-D57A-7D44-8961-422A86E6230B}" type="datetimeFigureOut">
              <a:t>2022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642E-D1AF-5648-8619-8490CD5329B2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4230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ABEE-D57A-7D44-8961-422A86E6230B}" type="datetimeFigureOut">
              <a:t>2022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642E-D1AF-5648-8619-8490CD5329B2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2237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ABEE-D57A-7D44-8961-422A86E6230B}" type="datetimeFigureOut">
              <a:t>2022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642E-D1AF-5648-8619-8490CD5329B2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6677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ABEE-D57A-7D44-8961-422A86E6230B}" type="datetimeFigureOut">
              <a:t>2022/6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642E-D1AF-5648-8619-8490CD5329B2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0257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ABEE-D57A-7D44-8961-422A86E6230B}" type="datetimeFigureOut">
              <a:t>2022/6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642E-D1AF-5648-8619-8490CD5329B2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8044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ABEE-D57A-7D44-8961-422A86E6230B}" type="datetimeFigureOut">
              <a:t>2022/6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642E-D1AF-5648-8619-8490CD5329B2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0820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ABEE-D57A-7D44-8961-422A86E6230B}" type="datetimeFigureOut">
              <a:t>2022/6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642E-D1AF-5648-8619-8490CD5329B2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3505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ABEE-D57A-7D44-8961-422A86E6230B}" type="datetimeFigureOut">
              <a:t>2022/6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642E-D1AF-5648-8619-8490CD5329B2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18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dirty="0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BABEE-D57A-7D44-8961-422A86E6230B}" type="datetimeFigureOut">
              <a:t>2022/6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642E-D1AF-5648-8619-8490CD5329B2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0780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3BABEE-D57A-7D44-8961-422A86E6230B}" type="datetimeFigureOut">
              <a:t>2022/6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3642E-D1AF-5648-8619-8490CD5329B2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2947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42103" y="2703193"/>
            <a:ext cx="6573794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dditional file 2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2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le format: </a:t>
            </a:r>
            <a:r>
              <a:rPr lang="en-US" altLang="ja-JP" sz="1200" b="1" kern="100" dirty="0" err="1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ptx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1.</a:t>
            </a:r>
            <a:r>
              <a:rPr lang="en-US" altLang="ja-JP" sz="12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Dot-plot alignments of assembled </a:t>
            </a:r>
            <a:r>
              <a:rPr lang="en-US" altLang="ja-JP" sz="1200" kern="100" dirty="0" err="1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ntigs</a:t>
            </a:r>
            <a:r>
              <a:rPr lang="en-US" altLang="ja-JP" sz="12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vs. the reference </a:t>
            </a:r>
            <a:r>
              <a:rPr lang="en-US" altLang="ja-JP" sz="1200" kern="100" dirty="0" err="1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itogenome</a:t>
            </a:r>
            <a:r>
              <a:rPr lang="en-US" altLang="ja-JP" sz="12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MN104801 and MN104802) of cv. </a:t>
            </a:r>
            <a:r>
              <a:rPr lang="en-US" altLang="ja-JP" sz="1200" kern="100" dirty="0" err="1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ésirée</a:t>
            </a:r>
            <a:r>
              <a:rPr lang="en-US" altLang="ja-JP" sz="12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2.</a:t>
            </a:r>
            <a:r>
              <a:rPr lang="en-US" altLang="ja-JP" sz="12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equence of the intergenic region between </a:t>
            </a:r>
            <a:r>
              <a:rPr lang="en-US" altLang="ja-JP" sz="1200" i="1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pl5-ψrps14 </a:t>
            </a:r>
            <a:r>
              <a:rPr lang="en-US" altLang="ja-JP" sz="12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nd </a:t>
            </a:r>
            <a:r>
              <a:rPr lang="en-US" altLang="ja-JP" sz="1200" i="1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ad6 </a:t>
            </a:r>
            <a:r>
              <a:rPr lang="en-US" altLang="ja-JP" sz="12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P-3) in cv. </a:t>
            </a:r>
            <a:r>
              <a:rPr lang="en-US" altLang="ja-JP" sz="1200" kern="100" dirty="0" err="1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lwara</a:t>
            </a:r>
            <a:r>
              <a:rPr lang="en-US" altLang="ja-JP" sz="1200" kern="100" dirty="0" smtClean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3.</a:t>
            </a:r>
            <a:r>
              <a:rPr lang="en-US" altLang="ja-JP" sz="12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equence of the intergenic region between </a:t>
            </a:r>
            <a:r>
              <a:rPr lang="en-US" altLang="ja-JP" sz="1200" i="1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pl1</a:t>
            </a:r>
            <a:r>
              <a:rPr lang="en-US" altLang="ja-JP" sz="12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d </a:t>
            </a:r>
            <a:r>
              <a:rPr lang="en-US" altLang="ja-JP" sz="1200" i="1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x2-partial </a:t>
            </a:r>
            <a:r>
              <a:rPr lang="en-US" altLang="ja-JP" sz="12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P-5) in cv. </a:t>
            </a:r>
            <a:r>
              <a:rPr lang="en-US" altLang="ja-JP" sz="1200" kern="100" dirty="0" err="1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lwara</a:t>
            </a:r>
            <a:r>
              <a:rPr lang="en-US" altLang="ja-JP" sz="12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4.</a:t>
            </a:r>
            <a:r>
              <a:rPr lang="en-US" altLang="ja-JP" sz="12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Photographs of full-length electrophoresed gels used for Figure 3. Stoichiometric differences between P-3 and the 859-bp band via (</a:t>
            </a:r>
            <a:r>
              <a:rPr lang="en-US" altLang="ja-JP" sz="1200" b="1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rpl5rps14outF/nad6 and (</a:t>
            </a:r>
            <a:r>
              <a:rPr lang="en-US" altLang="ja-JP" sz="1200" b="1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2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rpl5rps14outF/ALM5 (for the </a:t>
            </a:r>
            <a:r>
              <a:rPr lang="en-US" altLang="ja-JP" sz="1200" kern="100" dirty="0" smtClean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859-bp band</a:t>
            </a:r>
            <a:r>
              <a:rPr lang="en-US" altLang="ja-JP" sz="12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primer sets.</a:t>
            </a:r>
            <a:endParaRPr lang="ja-JP" altLang="ja-JP" sz="12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68822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ECEAD4F-CF68-444F-94BC-BA07046D7C46}"/>
              </a:ext>
            </a:extLst>
          </p:cNvPr>
          <p:cNvSpPr txBox="1"/>
          <p:nvPr/>
        </p:nvSpPr>
        <p:spPr>
          <a:xfrm>
            <a:off x="1236143" y="866295"/>
            <a:ext cx="15135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Pollen-fertile clones</a:t>
            </a: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64C7E98-90CF-5F44-A2DF-97E62D3F29B2}"/>
              </a:ext>
            </a:extLst>
          </p:cNvPr>
          <p:cNvSpPr txBox="1"/>
          <p:nvPr/>
        </p:nvSpPr>
        <p:spPr>
          <a:xfrm>
            <a:off x="1236143" y="3578545"/>
            <a:ext cx="11492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T-CMS clones</a:t>
            </a: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2B9C47F-313D-F040-8F4A-9CA4E69C40CA}"/>
              </a:ext>
            </a:extLst>
          </p:cNvPr>
          <p:cNvSpPr txBox="1"/>
          <p:nvPr/>
        </p:nvSpPr>
        <p:spPr>
          <a:xfrm>
            <a:off x="2770738" y="6299002"/>
            <a:ext cx="10166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cultivar </a:t>
            </a:r>
            <a:r>
              <a:rPr kumimoji="1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Alwara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3C5C465B-725F-334A-B5CD-E09E6634E6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0823" y="1289154"/>
            <a:ext cx="2232789" cy="2244708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4F9DE0F7-9CC3-6948-9D5E-AA848583302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931"/>
          <a:stretch/>
        </p:blipFill>
        <p:spPr>
          <a:xfrm>
            <a:off x="3970415" y="1289154"/>
            <a:ext cx="2232789" cy="2229232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D0FD8EDD-C042-E949-B574-4CA2EF6FDAD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492" b="1513"/>
          <a:stretch/>
        </p:blipFill>
        <p:spPr>
          <a:xfrm>
            <a:off x="1540822" y="4016870"/>
            <a:ext cx="2232790" cy="2211856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50BF0DF5-2AE3-BD4F-97A9-1A8AB68FF9E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70415" y="4016870"/>
            <a:ext cx="2232790" cy="2224879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0087FF9-EDD9-8D49-94C9-A00DDA8948CD}"/>
              </a:ext>
            </a:extLst>
          </p:cNvPr>
          <p:cNvSpPr txBox="1"/>
          <p:nvPr/>
        </p:nvSpPr>
        <p:spPr>
          <a:xfrm>
            <a:off x="1547979" y="1056748"/>
            <a:ext cx="7441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17H117-9</a:t>
            </a:r>
            <a:endParaRPr kumimoji="1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82BC933-9643-C445-966C-B568C0D0AA2E}"/>
              </a:ext>
            </a:extLst>
          </p:cNvPr>
          <p:cNvSpPr txBox="1"/>
          <p:nvPr/>
        </p:nvSpPr>
        <p:spPr>
          <a:xfrm>
            <a:off x="3976301" y="1069948"/>
            <a:ext cx="6303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17H131</a:t>
            </a:r>
            <a:endParaRPr kumimoji="1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EEB985A-9BE5-004C-BE32-59BB7C74B5DE}"/>
              </a:ext>
            </a:extLst>
          </p:cNvPr>
          <p:cNvSpPr txBox="1"/>
          <p:nvPr/>
        </p:nvSpPr>
        <p:spPr>
          <a:xfrm>
            <a:off x="1574243" y="3789442"/>
            <a:ext cx="6303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15H156</a:t>
            </a:r>
            <a:endParaRPr kumimoji="1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89388AB-1D5D-EA4C-B95D-51C4D9286911}"/>
              </a:ext>
            </a:extLst>
          </p:cNvPr>
          <p:cNvSpPr txBox="1"/>
          <p:nvPr/>
        </p:nvSpPr>
        <p:spPr>
          <a:xfrm>
            <a:off x="3979136" y="3791769"/>
            <a:ext cx="6303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18H225</a:t>
            </a:r>
            <a:endParaRPr kumimoji="1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0FAE4370-902C-A84C-810C-B9F436936AC7}"/>
              </a:ext>
            </a:extLst>
          </p:cNvPr>
          <p:cNvSpPr/>
          <p:nvPr/>
        </p:nvSpPr>
        <p:spPr>
          <a:xfrm>
            <a:off x="1083502" y="8853983"/>
            <a:ext cx="553113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igure S1</a:t>
            </a:r>
            <a:r>
              <a:rPr lang="en-US" altLang="ja-JP" sz="1000" b="1" dirty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</a:t>
            </a: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Dot-plot alignments of assembled contigs vs. the reference mitogenome (MN104801 and </a:t>
            </a:r>
            <a:r>
              <a:rPr lang="en-US" altLang="ja-JP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N104802) </a:t>
            </a: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of cv. </a:t>
            </a:r>
            <a:r>
              <a:rPr lang="en-US" altLang="ja-JP" sz="1000" dirty="0" err="1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Désirée</a:t>
            </a:r>
            <a:r>
              <a:rPr lang="en-US" altLang="ja-JP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 </a:t>
            </a:r>
            <a:endParaRPr lang="en-US" altLang="ja-JP" sz="1000" dirty="0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8959ACE3-5846-014A-98BA-0E68175A1F3D}"/>
              </a:ext>
            </a:extLst>
          </p:cNvPr>
          <p:cNvGrpSpPr/>
          <p:nvPr/>
        </p:nvGrpSpPr>
        <p:grpSpPr>
          <a:xfrm>
            <a:off x="2781993" y="6535032"/>
            <a:ext cx="2249765" cy="2232789"/>
            <a:chOff x="2781993" y="6535032"/>
            <a:chExt cx="2249765" cy="2232789"/>
          </a:xfrm>
        </p:grpSpPr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83E39416-6CAE-3140-87F4-BCE0FA3F297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781993" y="6535032"/>
              <a:ext cx="2234768" cy="2232789"/>
            </a:xfrm>
            <a:prstGeom prst="rect">
              <a:avLst/>
            </a:prstGeom>
          </p:spPr>
        </p:pic>
        <p:sp>
          <p:nvSpPr>
            <p:cNvPr id="19" name="円/楕円 18">
              <a:extLst>
                <a:ext uri="{FF2B5EF4-FFF2-40B4-BE49-F238E27FC236}">
                  <a16:creationId xmlns:a16="http://schemas.microsoft.com/office/drawing/2014/main" id="{2BCADF05-A648-B946-95C3-A5DC99CA570A}"/>
                </a:ext>
              </a:extLst>
            </p:cNvPr>
            <p:cNvSpPr/>
            <p:nvPr/>
          </p:nvSpPr>
          <p:spPr>
            <a:xfrm>
              <a:off x="4921709" y="7745427"/>
              <a:ext cx="71864" cy="48552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AD5A24E4-12CD-F64D-A9A4-909B0FF8B79B}"/>
                </a:ext>
              </a:extLst>
            </p:cNvPr>
            <p:cNvSpPr txBox="1"/>
            <p:nvPr/>
          </p:nvSpPr>
          <p:spPr>
            <a:xfrm rot="5400000">
              <a:off x="4841001" y="7682173"/>
              <a:ext cx="219932" cy="161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450">
                  <a:latin typeface="Meiryo UI" panose="020B0604030504040204" pitchFamily="34" charset="-128"/>
                  <a:ea typeface="Meiryo UI" panose="020B0604030504040204" pitchFamily="34" charset="-128"/>
                  <a:cs typeface="Arial" panose="020B0604020202020204" pitchFamily="34" charset="0"/>
                </a:rPr>
                <a:t>1</a:t>
              </a:r>
              <a:endParaRPr kumimoji="1" lang="ja-JP" altLang="en-US" sz="450">
                <a:latin typeface="Meiryo UI" panose="020B0604030504040204" pitchFamily="34" charset="-128"/>
                <a:ea typeface="Meiryo UI" panose="020B0604030504040204" pitchFamily="34" charset="-128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027382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989AE3DC-79B2-B049-B938-80990085FF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7304" y="1350854"/>
            <a:ext cx="5471195" cy="4465529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97AB2F3-F422-D749-A464-28300EAA2518}"/>
              </a:ext>
            </a:extLst>
          </p:cNvPr>
          <p:cNvSpPr txBox="1"/>
          <p:nvPr/>
        </p:nvSpPr>
        <p:spPr>
          <a:xfrm>
            <a:off x="837304" y="6179636"/>
            <a:ext cx="533489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Figure S2. 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Sequence of the intergenic region between </a:t>
            </a:r>
            <a:r>
              <a:rPr lang="en-US" altLang="ja-JP" sz="1000" i="1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rpl5-ψrps14 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nd </a:t>
            </a:r>
            <a:r>
              <a:rPr lang="en-US" altLang="ja-JP" sz="1000" i="1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nad6 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(P-3) in cv.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lwara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 </a:t>
            </a:r>
            <a:endParaRPr lang="en-US" altLang="ja-JP" sz="1000" kern="100" dirty="0" smtClean="0"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  <a:p>
            <a:endParaRPr lang="en-US" altLang="ja-JP" sz="1000" kern="100" dirty="0"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  <a:p>
            <a:r>
              <a:rPr lang="ja-JP" altLang="ja-JP" sz="1000" kern="1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mer </a:t>
            </a:r>
            <a:r>
              <a:rPr lang="ja-JP" altLang="ja-JP" sz="10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quences in </a:t>
            </a:r>
            <a:r>
              <a:rPr lang="ja-JP" altLang="ja-JP" sz="1000" b="1" kern="1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ja-JP" altLang="ja-JP" sz="10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ja-JP" altLang="ja-JP" sz="10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ein coding genes are </a:t>
            </a:r>
            <a:r>
              <a:rPr lang="ja-JP" altLang="ja-JP" sz="1000" b="1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derlined</a:t>
            </a:r>
            <a:r>
              <a:rPr lang="ja-JP" altLang="ja-JP" sz="10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Nucleotide substitutions and insertion points occurred in other clones shown in </a:t>
            </a:r>
            <a:r>
              <a:rPr lang="en-US" altLang="ja-JP" sz="1000" b="1" kern="100" dirty="0">
                <a:solidFill>
                  <a:srgbClr val="0432FF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blue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letters and </a:t>
            </a:r>
            <a:r>
              <a:rPr lang="en-US" altLang="ja-JP" sz="1000" b="1" kern="100" dirty="0">
                <a:solidFill>
                  <a:srgbClr val="FF40FF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pink</a:t>
            </a:r>
            <a:r>
              <a:rPr lang="en-US" altLang="ja-JP" sz="1000" kern="100" dirty="0">
                <a:solidFill>
                  <a:srgbClr val="FF40FF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rrows, respectively. Homologous regions with four reads</a:t>
            </a:r>
            <a:r>
              <a:rPr lang="en-US" altLang="ja-JP" sz="1000" i="1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a 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to </a:t>
            </a:r>
            <a:r>
              <a:rPr lang="en-US" altLang="ja-JP" sz="1000" i="1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d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from pollen transcripts are indicated in </a:t>
            </a:r>
            <a:r>
              <a:rPr lang="en-US" altLang="ja-JP" sz="1000" b="1" i="1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Italic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 A108-bp and a 105-bp regions with high homology (&gt; 94 %) to those in M02 are highlighted in </a:t>
            </a:r>
            <a:r>
              <a:rPr lang="en-US" altLang="ja-JP" sz="1000" b="1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gray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  </a:t>
            </a:r>
            <a:r>
              <a:rPr lang="ja-JP" altLang="ja-JP" sz="10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region showing homology to the pepper CMS line is </a:t>
            </a:r>
            <a:r>
              <a:rPr lang="ja-JP" altLang="ja-JP" sz="1000" b="1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uble-underlined</a:t>
            </a:r>
            <a:r>
              <a:rPr lang="ja-JP" altLang="ja-JP" sz="10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ja-JP" altLang="ja-JP" sz="1000" kern="100" dirty="0"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67017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97AB2F3-F422-D749-A464-28300EAA2518}"/>
              </a:ext>
            </a:extLst>
          </p:cNvPr>
          <p:cNvSpPr txBox="1"/>
          <p:nvPr/>
        </p:nvSpPr>
        <p:spPr>
          <a:xfrm>
            <a:off x="837304" y="6179636"/>
            <a:ext cx="533489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Figure S3. 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Sequence of the intergenic region between </a:t>
            </a:r>
            <a:r>
              <a:rPr lang="en-US" altLang="ja-JP" sz="1000" i="1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rpl1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and </a:t>
            </a:r>
            <a:r>
              <a:rPr lang="en-US" altLang="ja-JP" sz="1000" i="1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cox2-partial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(P-5) in cv.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lwara</a:t>
            </a:r>
            <a:r>
              <a:rPr lang="en-US" altLang="ja-JP" sz="1000" kern="100" dirty="0" smtClean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</a:t>
            </a:r>
          </a:p>
          <a:p>
            <a:endParaRPr lang="en-US" altLang="ja-JP" sz="1000" kern="100" dirty="0"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  <a:p>
            <a:r>
              <a:rPr lang="en-US" altLang="ja-JP" sz="1000" kern="1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mer </a:t>
            </a:r>
            <a:r>
              <a:rPr lang="en-US" altLang="ja-JP" sz="10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quences in </a:t>
            </a:r>
            <a:r>
              <a:rPr lang="en-US" altLang="ja-JP" sz="1000" b="1" kern="1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en-US" altLang="ja-JP" sz="10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Protein coding genes are </a:t>
            </a:r>
            <a:r>
              <a:rPr lang="en-US" altLang="ja-JP" sz="1000" b="1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derlined</a:t>
            </a:r>
            <a:r>
              <a:rPr lang="en-US" altLang="ja-JP" sz="10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A substitution from G to C in the </a:t>
            </a:r>
            <a:r>
              <a:rPr lang="en-US" altLang="ja-JP" sz="1000" b="1" kern="100" dirty="0">
                <a:solidFill>
                  <a:srgbClr val="0432FF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lue</a:t>
            </a:r>
            <a:r>
              <a:rPr lang="en-US" altLang="ja-JP" sz="10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ucleotide occurred in only one accession of </a:t>
            </a:r>
            <a:r>
              <a:rPr lang="en-US" altLang="ja-JP" sz="1000" i="1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ja-JP" sz="1000" i="1" kern="1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oloniferum</a:t>
            </a:r>
            <a:r>
              <a:rPr lang="en-US" altLang="ja-JP" sz="1000" i="1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PI 498000) and its hybrid.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44853051-A098-4545-98E1-B4D2EA64D5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3763" y="1883076"/>
            <a:ext cx="5561978" cy="39516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60558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97AB2F3-F422-D749-A464-28300EAA2518}"/>
              </a:ext>
            </a:extLst>
          </p:cNvPr>
          <p:cNvSpPr txBox="1"/>
          <p:nvPr/>
        </p:nvSpPr>
        <p:spPr>
          <a:xfrm>
            <a:off x="1187567" y="7142581"/>
            <a:ext cx="484738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Figure S4.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tographs of full-length electrophoresed gels used for Figure 3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oichiometric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ces between P-3 and the 859-bp band </a:t>
            </a:r>
            <a:r>
              <a:rPr kumimoji="1"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via (</a:t>
            </a:r>
            <a:r>
              <a:rPr kumimoji="1" lang="en-US" altLang="ja-JP" sz="1000" b="1" dirty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kumimoji="1"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</a:t>
            </a: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pl5rps14outF/nad6 and (</a:t>
            </a:r>
            <a:r>
              <a:rPr lang="en-US" altLang="ja-JP" sz="1000" b="1" dirty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rpl5rps14outF/ALM5 (for the </a:t>
            </a:r>
            <a:r>
              <a:rPr lang="en-US" altLang="ja-JP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859-bp band</a:t>
            </a: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primer sets.</a:t>
            </a:r>
            <a:endParaRPr lang="en-US" altLang="ja-JP" sz="1000" kern="1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214C6D8-3D0A-E64E-9F8D-DDE39BE1CD7D}"/>
              </a:ext>
            </a:extLst>
          </p:cNvPr>
          <p:cNvSpPr txBox="1"/>
          <p:nvPr/>
        </p:nvSpPr>
        <p:spPr>
          <a:xfrm>
            <a:off x="1477014" y="150758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3327EC0-F8CE-3D43-BAA8-3A3F2A27930E}"/>
              </a:ext>
            </a:extLst>
          </p:cNvPr>
          <p:cNvSpPr txBox="1"/>
          <p:nvPr/>
        </p:nvSpPr>
        <p:spPr>
          <a:xfrm>
            <a:off x="1477014" y="412185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6D060198-1F37-E215-034B-9592E22D11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1066" y="1799500"/>
            <a:ext cx="3615267" cy="2235757"/>
          </a:xfrm>
          <a:prstGeom prst="rect">
            <a:avLst/>
          </a:prstGeom>
        </p:spPr>
      </p:pic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1B1981C1-1EDF-C1E8-5135-AE9E5ED5D3CC}"/>
              </a:ext>
            </a:extLst>
          </p:cNvPr>
          <p:cNvSpPr/>
          <p:nvPr/>
        </p:nvSpPr>
        <p:spPr>
          <a:xfrm>
            <a:off x="2237661" y="1584568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1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11803C2B-05FC-F633-F5C1-78F5DF73E5B0}"/>
              </a:ext>
            </a:extLst>
          </p:cNvPr>
          <p:cNvSpPr/>
          <p:nvPr/>
        </p:nvSpPr>
        <p:spPr>
          <a:xfrm>
            <a:off x="2467336" y="1584568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2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9CE60B73-D391-D50B-B9B4-52B138ECB11D}"/>
              </a:ext>
            </a:extLst>
          </p:cNvPr>
          <p:cNvSpPr/>
          <p:nvPr/>
        </p:nvSpPr>
        <p:spPr>
          <a:xfrm>
            <a:off x="2668344" y="1584568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3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0C170A13-1E42-8766-8CD3-0EDE25FFB31B}"/>
              </a:ext>
            </a:extLst>
          </p:cNvPr>
          <p:cNvSpPr/>
          <p:nvPr/>
        </p:nvSpPr>
        <p:spPr>
          <a:xfrm>
            <a:off x="2861992" y="1584568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4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09BA7F0E-CCAD-ED3A-CA69-D766D1232285}"/>
              </a:ext>
            </a:extLst>
          </p:cNvPr>
          <p:cNvSpPr/>
          <p:nvPr/>
        </p:nvSpPr>
        <p:spPr>
          <a:xfrm>
            <a:off x="3063304" y="1584568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5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EAA2BFA2-3F1B-AF5C-42C4-AF139E3F8125}"/>
              </a:ext>
            </a:extLst>
          </p:cNvPr>
          <p:cNvSpPr/>
          <p:nvPr/>
        </p:nvSpPr>
        <p:spPr>
          <a:xfrm>
            <a:off x="3269445" y="1584568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6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6CAE7C67-6FC1-0F43-256C-44EBA50AFB42}"/>
              </a:ext>
            </a:extLst>
          </p:cNvPr>
          <p:cNvSpPr/>
          <p:nvPr/>
        </p:nvSpPr>
        <p:spPr>
          <a:xfrm>
            <a:off x="3460123" y="1584568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7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539B58CC-6EE3-9896-6130-DFED64BA815B}"/>
              </a:ext>
            </a:extLst>
          </p:cNvPr>
          <p:cNvSpPr/>
          <p:nvPr/>
        </p:nvSpPr>
        <p:spPr>
          <a:xfrm>
            <a:off x="3668756" y="1584568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8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CA0F15C9-880A-C750-655C-C157B4E0DEA4}"/>
              </a:ext>
            </a:extLst>
          </p:cNvPr>
          <p:cNvSpPr/>
          <p:nvPr/>
        </p:nvSpPr>
        <p:spPr>
          <a:xfrm>
            <a:off x="3859414" y="1584568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9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51F9AE3C-F816-3E29-905C-EE4E57B7C8AE}"/>
              </a:ext>
            </a:extLst>
          </p:cNvPr>
          <p:cNvSpPr/>
          <p:nvPr/>
        </p:nvSpPr>
        <p:spPr>
          <a:xfrm>
            <a:off x="3995484" y="1584568"/>
            <a:ext cx="3545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1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B9585C10-46CC-68A3-4B81-AC8AEA66B70B}"/>
              </a:ext>
            </a:extLst>
          </p:cNvPr>
          <p:cNvSpPr/>
          <p:nvPr/>
        </p:nvSpPr>
        <p:spPr>
          <a:xfrm>
            <a:off x="4224212" y="1584568"/>
            <a:ext cx="34317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11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43D32494-CEA3-C2A7-54BC-29076286486C}"/>
              </a:ext>
            </a:extLst>
          </p:cNvPr>
          <p:cNvSpPr/>
          <p:nvPr/>
        </p:nvSpPr>
        <p:spPr>
          <a:xfrm>
            <a:off x="4410426" y="1584568"/>
            <a:ext cx="3545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12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674E1C4E-E07F-B813-BADF-2DBC1EB0200A}"/>
              </a:ext>
            </a:extLst>
          </p:cNvPr>
          <p:cNvSpPr/>
          <p:nvPr/>
        </p:nvSpPr>
        <p:spPr>
          <a:xfrm>
            <a:off x="4635494" y="1584568"/>
            <a:ext cx="3545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13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D0540602-A82A-F22B-05E2-CD0D9531E1C9}"/>
              </a:ext>
            </a:extLst>
          </p:cNvPr>
          <p:cNvSpPr/>
          <p:nvPr/>
        </p:nvSpPr>
        <p:spPr>
          <a:xfrm>
            <a:off x="2309851" y="4167347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1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C0FD01E4-8F60-3948-9419-93D0526BBBDB}"/>
              </a:ext>
            </a:extLst>
          </p:cNvPr>
          <p:cNvSpPr/>
          <p:nvPr/>
        </p:nvSpPr>
        <p:spPr>
          <a:xfrm>
            <a:off x="2539526" y="4167347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2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6CC25D64-D447-413E-4092-820CFC73710F}"/>
              </a:ext>
            </a:extLst>
          </p:cNvPr>
          <p:cNvSpPr/>
          <p:nvPr/>
        </p:nvSpPr>
        <p:spPr>
          <a:xfrm>
            <a:off x="2740534" y="4167347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3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8E648FA0-79EC-0685-1B06-51834FBEE49C}"/>
              </a:ext>
            </a:extLst>
          </p:cNvPr>
          <p:cNvSpPr/>
          <p:nvPr/>
        </p:nvSpPr>
        <p:spPr>
          <a:xfrm>
            <a:off x="2934182" y="4167347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4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822E313A-EB86-0B18-EE17-EE965F95090F}"/>
              </a:ext>
            </a:extLst>
          </p:cNvPr>
          <p:cNvSpPr/>
          <p:nvPr/>
        </p:nvSpPr>
        <p:spPr>
          <a:xfrm>
            <a:off x="3135494" y="4167347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5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D26DB0A5-0CF1-5407-35F1-1E42AF48F6F5}"/>
              </a:ext>
            </a:extLst>
          </p:cNvPr>
          <p:cNvSpPr/>
          <p:nvPr/>
        </p:nvSpPr>
        <p:spPr>
          <a:xfrm>
            <a:off x="3341635" y="4167347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6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4A07C63D-8D86-D1D3-C2DD-23E5FD5261BA}"/>
              </a:ext>
            </a:extLst>
          </p:cNvPr>
          <p:cNvSpPr/>
          <p:nvPr/>
        </p:nvSpPr>
        <p:spPr>
          <a:xfrm>
            <a:off x="3532313" y="4167347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7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2970558B-D27C-425A-7A71-27B2EE7C1152}"/>
              </a:ext>
            </a:extLst>
          </p:cNvPr>
          <p:cNvSpPr/>
          <p:nvPr/>
        </p:nvSpPr>
        <p:spPr>
          <a:xfrm>
            <a:off x="3740946" y="4167347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8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39576BCF-DF69-E1BB-8FFA-6D73B42A82F4}"/>
              </a:ext>
            </a:extLst>
          </p:cNvPr>
          <p:cNvSpPr/>
          <p:nvPr/>
        </p:nvSpPr>
        <p:spPr>
          <a:xfrm>
            <a:off x="3931604" y="4167347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9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1C8C0277-A389-F52D-014C-4600DF6F6454}"/>
              </a:ext>
            </a:extLst>
          </p:cNvPr>
          <p:cNvSpPr/>
          <p:nvPr/>
        </p:nvSpPr>
        <p:spPr>
          <a:xfrm>
            <a:off x="4067674" y="4167347"/>
            <a:ext cx="3545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10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9D7DD27C-C214-1AB2-CC84-BE071491D88A}"/>
              </a:ext>
            </a:extLst>
          </p:cNvPr>
          <p:cNvSpPr/>
          <p:nvPr/>
        </p:nvSpPr>
        <p:spPr>
          <a:xfrm>
            <a:off x="4296402" y="4167347"/>
            <a:ext cx="34317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11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405611FD-C148-04A8-7018-9FA23AFEF514}"/>
              </a:ext>
            </a:extLst>
          </p:cNvPr>
          <p:cNvSpPr/>
          <p:nvPr/>
        </p:nvSpPr>
        <p:spPr>
          <a:xfrm>
            <a:off x="4482616" y="4167347"/>
            <a:ext cx="3545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12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ACE00B51-8077-6DE6-F752-8B1450C9EBA4}"/>
              </a:ext>
            </a:extLst>
          </p:cNvPr>
          <p:cNvSpPr/>
          <p:nvPr/>
        </p:nvSpPr>
        <p:spPr>
          <a:xfrm>
            <a:off x="4707684" y="4167347"/>
            <a:ext cx="3545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13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9737" y="4396010"/>
            <a:ext cx="3603048" cy="2213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07769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</TotalTime>
  <Words>370</Words>
  <Application>Microsoft Office PowerPoint</Application>
  <PresentationFormat>A4 210 x 297 mm</PresentationFormat>
  <Paragraphs>52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9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5" baseType="lpstr">
      <vt:lpstr>Meiryo UI</vt:lpstr>
      <vt:lpstr>ＭＳ 明朝</vt:lpstr>
      <vt:lpstr>游ゴシック</vt:lpstr>
      <vt:lpstr>游ゴシック Light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yoshi Hosaka</dc:creator>
  <cp:lastModifiedBy>Sanetomo Rena</cp:lastModifiedBy>
  <cp:revision>14</cp:revision>
  <dcterms:created xsi:type="dcterms:W3CDTF">2022-03-19T00:28:45Z</dcterms:created>
  <dcterms:modified xsi:type="dcterms:W3CDTF">2022-06-07T01:35:57Z</dcterms:modified>
</cp:coreProperties>
</file>